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6" r:id="rId2"/>
    <p:sldId id="268" r:id="rId3"/>
    <p:sldId id="267" r:id="rId4"/>
  </p:sldIdLst>
  <p:sldSz cx="12192000" cy="6858000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481" autoAdjust="0"/>
    <p:restoredTop sz="94660"/>
  </p:normalViewPr>
  <p:slideViewPr>
    <p:cSldViewPr snapToGrid="0">
      <p:cViewPr varScale="1">
        <p:scale>
          <a:sx n="65" d="100"/>
          <a:sy n="65" d="100"/>
        </p:scale>
        <p:origin x="7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r">
              <a:defRPr sz="1300"/>
            </a:lvl1pPr>
          </a:lstStyle>
          <a:p>
            <a:fld id="{E52A10BD-B12C-42DC-A9A3-1D88ED231CE5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39738" y="1252538"/>
            <a:ext cx="60086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6" tIns="48308" rIns="96616" bIns="48308" rtlCol="0" anchor="ctr"/>
          <a:lstStyle/>
          <a:p>
            <a:endParaRPr lang="ja-JP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817" y="4822269"/>
            <a:ext cx="5510530" cy="3945493"/>
          </a:xfrm>
          <a:prstGeom prst="rect">
            <a:avLst/>
          </a:prstGeom>
        </p:spPr>
        <p:txBody>
          <a:bodyPr vert="horz" lIns="96616" tIns="48308" rIns="96616" bIns="48308" rtlCol="0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1698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r">
              <a:defRPr sz="1300"/>
            </a:lvl1pPr>
          </a:lstStyle>
          <a:p>
            <a:fld id="{F5C26AB2-CF47-4302-88CA-F40600E3E0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2102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43958A-CB4E-B794-8E82-078A529D90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B260A76-9C00-7981-241E-ADBB0C266C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en-US" altLang="ja-JP"/>
              <a:t>Click to edit Master subtitle style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8178D2-A1E8-3EC4-8EB9-64C6475C5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28731-F709-2419-E1BC-FC3A22B39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AEA29D-DECA-2373-93DD-005CEA6EA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4296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6523D4-74F7-77E6-3353-AD4B7985A9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85EC76-71C5-FCE1-6D89-1350B02074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9F6F06-B3E1-AE09-D6A7-504791447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9B0DBC-E4C8-A018-4C81-D1E00480E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0408E2-E111-06A2-C1FF-D1AE8ABD2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5667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F230F73-96B8-8653-2745-AD34BD36254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DD70CC-C4D9-E785-9880-14B7305FD4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A498F9-F268-6A59-8480-522CD67AF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BBA08D-9100-B04E-BF44-ABE08710C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71B7D1-7241-2A4A-2E20-1811969AAD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56951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45BE4B-B92C-F5B3-4687-09A1597ADF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211F9F-07D2-35E7-A26C-71CA21BE2E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5BCFE7-D3C3-D74B-286F-26DF705FD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EEB0C9-5CA9-E0BE-0360-E67D6AE4C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88E970-86C8-E8CA-120B-C0886F61D5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2213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7AEF20-4564-9E99-7EA9-BDBE303CA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B592D2-BC5E-AB6D-068F-95215B44CB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C02EE5-E48B-1720-21E0-0EC96A357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B7D801-654B-40B7-8504-B37C86FFA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93750C-6031-8074-E7AE-09507DBA1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614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7062A2-6AA7-6902-250F-B029738835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FBD760-4227-07FB-1DE1-40720B4102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63E897-3E00-FF6E-A6B1-3BB1D9CFE6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1E4BB3-1C2C-2EF6-C4F4-FFB9289D3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432A9F-9703-42BE-B194-1851452B8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E4BA95-F2F8-1BED-3E4A-9D94EE773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936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65ACB6-8E9E-C52A-1E8B-55AB4E0FEF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78391E-B346-C02E-2832-94CA2F1ECA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3F068D-1639-633A-4847-F113AC2AE9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EA7FC41-0B68-182C-C8BF-2CF5128F7A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F4CF596-030B-174A-2C63-06CE1AA7CC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8BFCB6-5662-67F0-A9A3-99A7DC97FA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5352AE-84C0-84F7-D845-CB1B21126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3753A3F-DA14-4A02-C85C-6E7944B91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8335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E0F047-D5D6-F06B-A08C-34131EA468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102CD45-37F3-031B-F1A4-C4E32B315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FC0CE0-F608-47FD-B1D0-91C0C80149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EA97D9-197B-6313-A6FB-5CB22A9B5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3540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B4DDB8-6044-A304-A61A-3D7AB5586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0FE79B5-E2F3-0138-0A9D-767F02D98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C84BA4-B4E6-70F0-2D86-CDD5C2FD56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1202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D70969-D7AF-B18C-3834-3B7CA79389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B01C76-7FF6-503B-BCA7-D00CD64C9D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7C65A5-4468-9BB4-6CB9-36287745ED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463DD6-5D4F-626B-534A-B70546FE6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3FB251-F6E7-2953-5F3B-CB2A32E07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EEF864-09FB-4D8F-63B4-7F77A582D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0493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A7A6B-A675-BA98-2E18-67BD263825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3361C6-B4D7-DF8E-D2A6-5BEE52C1F7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6C81E8-A9D5-A06C-1AE4-EDB042A790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FECC53-4D4B-84AA-E858-BD0A876F2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95EB72-9592-8FB0-1F42-59D41B65D0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B31E91-F5B6-1051-D931-06641FF6AA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75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0B051D-6229-8009-8D1C-B9EB12F69C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78E278-748F-06E1-25FD-1FADE12D09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7CEC16-DD28-6D5C-6BE7-AAAACD3343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4DE7E00-D2C7-4E0D-AAC7-1F9532C23D2A}" type="datetimeFigureOut">
              <a:rPr kumimoji="1" lang="ja-JP" altLang="en-US" smtClean="0"/>
              <a:t>2025/2/14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FA0C14-C635-113C-B080-FC629499CB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B4B1BC-A3BB-1FC0-EFBE-313E8F6FCE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E19FBE9-A895-4365-8D87-8D383447B2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5379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9C784AAE-D854-1B1B-B06D-49F0BC30168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9561" r="83684" b="3597"/>
          <a:stretch/>
        </p:blipFill>
        <p:spPr>
          <a:xfrm>
            <a:off x="7110855" y="199931"/>
            <a:ext cx="1491915" cy="541853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45F09BF-9121-8DA9-40A6-8DDFAE768550}"/>
              </a:ext>
            </a:extLst>
          </p:cNvPr>
          <p:cNvSpPr txBox="1"/>
          <p:nvPr/>
        </p:nvSpPr>
        <p:spPr>
          <a:xfrm>
            <a:off x="8891341" y="801373"/>
            <a:ext cx="16825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M      N      1          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EFAA11F-86FB-3F14-CFFC-E589147C066E}"/>
              </a:ext>
            </a:extLst>
          </p:cNvPr>
          <p:cNvSpPr txBox="1"/>
          <p:nvPr/>
        </p:nvSpPr>
        <p:spPr>
          <a:xfrm>
            <a:off x="2671804" y="663539"/>
            <a:ext cx="527509" cy="41549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294E585-3DF3-03FD-18B9-69FC653EC295}"/>
              </a:ext>
            </a:extLst>
          </p:cNvPr>
          <p:cNvSpPr txBox="1"/>
          <p:nvPr/>
        </p:nvSpPr>
        <p:spPr>
          <a:xfrm>
            <a:off x="356791" y="5874236"/>
            <a:ext cx="11478418" cy="92333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 anchor="ctr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Detection of the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t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specific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ckettsi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 (M: marker, N: negative control, and the numbers of positive samples from 1 to 5 for camel. B: Detection of the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t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specific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ckettsi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 for dog sample</a:t>
            </a:r>
          </a:p>
        </p:txBody>
      </p:sp>
      <p:pic>
        <p:nvPicPr>
          <p:cNvPr id="12" name="Picture 11" descr="A close-up of a film&#10;&#10;AI-generated content may be incorrect.">
            <a:extLst>
              <a:ext uri="{FF2B5EF4-FFF2-40B4-BE49-F238E27FC236}">
                <a16:creationId xmlns:a16="http://schemas.microsoft.com/office/drawing/2014/main" id="{8D6C5288-34BA-5014-848E-8589C5CC677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74" t="27033" r="67753" b="2637"/>
          <a:stretch/>
        </p:blipFill>
        <p:spPr>
          <a:xfrm>
            <a:off x="3056758" y="199933"/>
            <a:ext cx="2621504" cy="538947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1EC9280-847B-85E6-8D70-CC3139C09926}"/>
              </a:ext>
            </a:extLst>
          </p:cNvPr>
          <p:cNvSpPr txBox="1"/>
          <p:nvPr/>
        </p:nvSpPr>
        <p:spPr>
          <a:xfrm>
            <a:off x="3180350" y="663539"/>
            <a:ext cx="31836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M </a:t>
            </a:r>
            <a:r>
              <a:rPr kumimoji="0" lang="ar-EG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N       </a:t>
            </a:r>
            <a:r>
              <a:rPr lang="en-GB" sz="1200" b="1" noProof="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   2        </a:t>
            </a:r>
            <a:r>
              <a:rPr lang="en-GB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en-GB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  <a:r>
              <a:rPr lang="en-GB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    </a:t>
            </a:r>
            <a:r>
              <a:rPr lang="en-GB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668F87C-3B9B-67EA-9C4C-6F9BE15EBF4E}"/>
              </a:ext>
            </a:extLst>
          </p:cNvPr>
          <p:cNvSpPr txBox="1"/>
          <p:nvPr/>
        </p:nvSpPr>
        <p:spPr>
          <a:xfrm>
            <a:off x="6702815" y="663539"/>
            <a:ext cx="527509" cy="40934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FCA8B7-19C5-F947-D17F-24B011AD3901}"/>
              </a:ext>
            </a:extLst>
          </p:cNvPr>
          <p:cNvSpPr txBox="1"/>
          <p:nvPr/>
        </p:nvSpPr>
        <p:spPr>
          <a:xfrm>
            <a:off x="7328235" y="620559"/>
            <a:ext cx="16825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M      N      1          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D966862-B266-B0C8-AF2D-DF901A72BECF}"/>
              </a:ext>
            </a:extLst>
          </p:cNvPr>
          <p:cNvSpPr/>
          <p:nvPr/>
        </p:nvSpPr>
        <p:spPr>
          <a:xfrm>
            <a:off x="3084098" y="5275505"/>
            <a:ext cx="289004" cy="31389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B730C3C1-EFCA-801A-2021-DA431157AE5F}"/>
              </a:ext>
            </a:extLst>
          </p:cNvPr>
          <p:cNvSpPr/>
          <p:nvPr/>
        </p:nvSpPr>
        <p:spPr>
          <a:xfrm>
            <a:off x="7110855" y="5275505"/>
            <a:ext cx="289004" cy="31389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77518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39FBCBE-82D3-D4B4-C637-0DDDABF65FF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50000"/>
          <a:stretch/>
        </p:blipFill>
        <p:spPr>
          <a:xfrm>
            <a:off x="3795712" y="175743"/>
            <a:ext cx="4600575" cy="558962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7B0256E-CC58-B6AA-963C-CF6861A7DBA2}"/>
              </a:ext>
            </a:extLst>
          </p:cNvPr>
          <p:cNvSpPr txBox="1"/>
          <p:nvPr/>
        </p:nvSpPr>
        <p:spPr>
          <a:xfrm>
            <a:off x="355599" y="5765367"/>
            <a:ext cx="11480800" cy="92333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 anchor="ctr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ion of the 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S rRNA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specific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ancisella-like endosymbiont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: marker, N: negative control, and the numbers of positive samples of camels from number 1 to 2 and the numbers of positive samples of dog number 3 and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728632D-0A07-421D-CA7B-40A191BF8B8F}"/>
              </a:ext>
            </a:extLst>
          </p:cNvPr>
          <p:cNvSpPr txBox="1"/>
          <p:nvPr/>
        </p:nvSpPr>
        <p:spPr>
          <a:xfrm>
            <a:off x="3268203" y="175743"/>
            <a:ext cx="527509" cy="43396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2EF4244-FE23-BF85-8861-32C0AC8ECB86}"/>
              </a:ext>
            </a:extLst>
          </p:cNvPr>
          <p:cNvSpPr txBox="1"/>
          <p:nvPr/>
        </p:nvSpPr>
        <p:spPr>
          <a:xfrm>
            <a:off x="4323221" y="376948"/>
            <a:ext cx="393044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M              N               </a:t>
            </a:r>
            <a:r>
              <a:rPr lang="en-GB" sz="1200" b="1" noProof="0" dirty="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2                  </a:t>
            </a:r>
            <a:r>
              <a:rPr lang="en-GB" sz="1200" b="1" dirty="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       </a:t>
            </a:r>
            <a:r>
              <a:rPr lang="en-GB" sz="1200" b="1" dirty="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en-GB" sz="12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9918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65B8245-C97F-B5B9-60D3-A8F628EDF0C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468" t="22419" r="29385" b="4032"/>
          <a:stretch/>
        </p:blipFill>
        <p:spPr>
          <a:xfrm>
            <a:off x="2804128" y="730411"/>
            <a:ext cx="6215146" cy="510576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24D6B76-F558-3444-1808-D69884A81D9F}"/>
              </a:ext>
            </a:extLst>
          </p:cNvPr>
          <p:cNvSpPr txBox="1"/>
          <p:nvPr/>
        </p:nvSpPr>
        <p:spPr>
          <a:xfrm>
            <a:off x="2390274" y="1069952"/>
            <a:ext cx="558232" cy="36625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3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noProof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500</a:t>
            </a:r>
            <a:endParaRPr lang="en-GB" sz="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00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876CDE2-0304-DB2C-C3AE-D844DCD81010}"/>
              </a:ext>
            </a:extLst>
          </p:cNvPr>
          <p:cNvSpPr txBox="1"/>
          <p:nvPr/>
        </p:nvSpPr>
        <p:spPr>
          <a:xfrm>
            <a:off x="3172727" y="957978"/>
            <a:ext cx="621514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M         N           </a:t>
            </a:r>
            <a:r>
              <a:rPr lang="en-GB" sz="1200" b="1" noProof="0" dirty="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      2          </a:t>
            </a:r>
            <a:r>
              <a:rPr lang="en-GB" sz="1200" b="1" dirty="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          </a:t>
            </a:r>
            <a:r>
              <a:rPr lang="en-GB" sz="1200" b="1" dirty="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          5          6          7           8         9         10</a:t>
            </a:r>
            <a:endParaRPr kumimoji="0" lang="en-GB" sz="12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C190970-0AE4-FA17-1AAB-0697EF0E4252}"/>
              </a:ext>
            </a:extLst>
          </p:cNvPr>
          <p:cNvSpPr txBox="1"/>
          <p:nvPr/>
        </p:nvSpPr>
        <p:spPr>
          <a:xfrm>
            <a:off x="170775" y="6063741"/>
            <a:ext cx="11850449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 anchor="ctr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3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ion of the </a:t>
            </a:r>
            <a:r>
              <a:rPr lang="en-US" sz="1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B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specific for </a:t>
            </a:r>
            <a:r>
              <a:rPr lang="en-GB" altLang="ja-JP" sz="18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orrelia theileri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: marker, N: negative control, and the numbers of positive samples of dogs with numbers 1, 3, 4, 6 and 10.</a:t>
            </a:r>
          </a:p>
        </p:txBody>
      </p:sp>
    </p:spTree>
    <p:extLst>
      <p:ext uri="{BB962C8B-B14F-4D97-AF65-F5344CB8AC3E}">
        <p14:creationId xmlns:p14="http://schemas.microsoft.com/office/powerpoint/2010/main" val="9326944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7</TotalTime>
  <Words>210</Words>
  <Application>Microsoft Office PowerPoint</Application>
  <PresentationFormat>Widescreen</PresentationFormat>
  <Paragraphs>11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liman Ahmed</dc:creator>
  <cp:lastModifiedBy>hassan youssef</cp:lastModifiedBy>
  <cp:revision>26</cp:revision>
  <cp:lastPrinted>2024-09-05T07:32:59Z</cp:lastPrinted>
  <dcterms:created xsi:type="dcterms:W3CDTF">2024-09-04T02:45:47Z</dcterms:created>
  <dcterms:modified xsi:type="dcterms:W3CDTF">2025-02-14T12:35:45Z</dcterms:modified>
</cp:coreProperties>
</file>